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2" autoAdjust="0"/>
    <p:restoredTop sz="94694"/>
  </p:normalViewPr>
  <p:slideViewPr>
    <p:cSldViewPr snapToGrid="0" showGuides="1">
      <p:cViewPr varScale="1">
        <p:scale>
          <a:sx n="121" d="100"/>
          <a:sy n="121" d="100"/>
        </p:scale>
        <p:origin x="648" y="176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3BA8FD-13A0-4BDB-9A1F-341D240E6A2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4873CB-6471-423D-99BF-96995CF6B58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66299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4873CB-6471-423D-99BF-96995CF6B580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97049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0F38B-E2D9-0B82-5040-4A0CC525DA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3B0686-D05E-B076-7FB5-05D4334A1D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3F044-5D25-CB4F-0A10-F358BDE04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6226ED-3034-E3F7-5CCF-646922096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2858D-EA9F-65F9-6EBD-BC533F78A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6834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62FFF0-B2DF-9D99-41D4-D21CA3435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5D9CD5-0651-C4F3-9791-5CCC36A1CD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1423E-ECD4-74E8-4DB7-F8C75DA16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CA51B-42F9-62BB-0BF1-588163D08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D11A2-CEE8-BAF9-6E39-582FC01BD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6675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A66481-E0FF-C841-82BC-33C4D7A430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018BF5-169E-97F1-A8E4-0AE534B218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A9DECF-9805-8D89-DB09-F5053FD35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E4D7E4-8E84-DAC7-CBB9-54E8692C0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62EA3B-59D4-77A2-8DAD-52B0601EE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4307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DF58E-431C-DB01-8E6F-F5A35F530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87F539-7B7B-DE11-A8E2-B217D3C156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34CC0D-8821-F73C-C7B1-6156B930B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044FE-6ED5-8B33-143E-A5D191037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78AF4A-4E37-20D8-A6C9-4DE8426B4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0059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740F-FE58-4C44-CBE0-9D08B3C5C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DA17AD-0C43-CE31-473A-A455E6779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BA1A89-8017-208E-131C-DE1DDAE1B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6B65CA-F315-AE01-B5FE-6E747F9E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AA05F-7059-EE9E-F13D-BEE5C5CC0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6923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F0921-6AAE-8A94-3944-6F7F890CEA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1CDAD0-66B3-D23D-39ED-4451BAC4CB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0AC6FC-59F5-9CBD-C31F-4AEF75C515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7AB2EA-518A-9E28-E5BD-58D95E4F8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377338-1AD2-6E90-0239-F9A04091E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97F416-D633-4403-4E39-51FA6DC96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2744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1C9C46-09AA-4A38-1AD9-F49B6F059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4F7129-5B0E-BD8B-CFCB-66FFEAABDD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506D0E-49D2-7FCA-0120-ED75F82BB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937AE8-57FE-83F9-1D84-27B843C391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240F15-58FB-03C9-1901-759FCB5486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37EFDE5-3C72-E626-18F6-C0E8A9070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C18066-1452-8F22-B700-066181149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37F79B-514E-0F8D-2EF0-9076509B0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6178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31BF6-601B-C6B7-B4E7-DE83A5C02D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CD0E1A-2541-61C5-C41D-A84E7E1F4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6F373D-7250-8BCE-7A89-5CBDD4A36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2EDCCA-954A-747B-F5D5-0FD01D7EF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5346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4262D0-3BB5-1006-F29E-104B9AD11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9EBF7D-D044-38DB-46B9-A34B9008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0D7022-62CA-3566-F34F-24DF455C9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2552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CB46C9-C070-ACBE-87DD-CD660689A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3DCFE1-A6DF-A38B-4224-975C8E6E92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BD8D5D-4DB0-990F-2172-6CD8DEF3F9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68B891-C130-78A3-43B9-F848A0F00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7023A7-E02D-5C99-656F-44B7F3345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1BA288-B1CA-DF1A-9C8A-404F06FB0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6320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9F910-D5BA-4697-AC4E-DF9CB7A8E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0A2B20-923C-B49B-965C-665CE115CD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4CAF70-99ED-8922-E54E-CE6D7F28BB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1B2247-211B-7CEB-36DB-52CC701CD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BA164D-CCDE-BAB9-E27B-1628C49E9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D2AA21-5432-FEBB-3920-8319228FD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2612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796884-B1AD-AD78-8649-D774A7BD7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E293C-C7D5-B57C-BC6D-82EA5C3A39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59FAAC-1CA4-1E5F-A17F-77E6DFA0B2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A72F593-F50B-4D0D-A8CD-C03C07BBDD08}" type="datetimeFigureOut">
              <a:rPr lang="it-IT" smtClean="0"/>
              <a:t>22/09/24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18B82F-48AB-AEAC-EDB9-BD9C6F3607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9EAC36-CB00-6C5D-2401-9BDCCCBE79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E2ECD4-FD77-4B43-BB72-7CB17B8002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0923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rrow: Pentagon 3">
            <a:extLst>
              <a:ext uri="{FF2B5EF4-FFF2-40B4-BE49-F238E27FC236}">
                <a16:creationId xmlns:a16="http://schemas.microsoft.com/office/drawing/2014/main" id="{0491DEA1-0F19-703A-EA10-228C6A3F970F}"/>
              </a:ext>
            </a:extLst>
          </p:cNvPr>
          <p:cNvSpPr/>
          <p:nvPr/>
        </p:nvSpPr>
        <p:spPr>
          <a:xfrm>
            <a:off x="166624" y="311468"/>
            <a:ext cx="4007795" cy="1295400"/>
          </a:xfrm>
          <a:prstGeom prst="homePlate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dirty="0"/>
              <a:t>Set up and review literature</a:t>
            </a:r>
            <a:endParaRPr lang="it-IT" sz="2400" dirty="0">
              <a:solidFill>
                <a:schemeClr val="bg1"/>
              </a:solidFill>
            </a:endParaRPr>
          </a:p>
        </p:txBody>
      </p:sp>
      <p:sp>
        <p:nvSpPr>
          <p:cNvPr id="5" name="Arrow: Chevron 4">
            <a:extLst>
              <a:ext uri="{FF2B5EF4-FFF2-40B4-BE49-F238E27FC236}">
                <a16:creationId xmlns:a16="http://schemas.microsoft.com/office/drawing/2014/main" id="{2C639AFA-75F5-06C9-6F22-B67E6C6B67F8}"/>
              </a:ext>
            </a:extLst>
          </p:cNvPr>
          <p:cNvSpPr/>
          <p:nvPr/>
        </p:nvSpPr>
        <p:spPr>
          <a:xfrm>
            <a:off x="4002969" y="318136"/>
            <a:ext cx="2634574" cy="1295400"/>
          </a:xfrm>
          <a:prstGeom prst="chevron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400" dirty="0">
                <a:solidFill>
                  <a:schemeClr val="bg1"/>
                </a:solidFill>
              </a:rPr>
              <a:t>Round 1</a:t>
            </a:r>
          </a:p>
        </p:txBody>
      </p:sp>
      <p:sp>
        <p:nvSpPr>
          <p:cNvPr id="6" name="Arrow: Chevron 5">
            <a:extLst>
              <a:ext uri="{FF2B5EF4-FFF2-40B4-BE49-F238E27FC236}">
                <a16:creationId xmlns:a16="http://schemas.microsoft.com/office/drawing/2014/main" id="{4B08DFA0-5D84-2B91-84C8-C49758463B3F}"/>
              </a:ext>
            </a:extLst>
          </p:cNvPr>
          <p:cNvSpPr/>
          <p:nvPr/>
        </p:nvSpPr>
        <p:spPr>
          <a:xfrm>
            <a:off x="6408466" y="324804"/>
            <a:ext cx="2670849" cy="1295400"/>
          </a:xfrm>
          <a:prstGeom prst="chevron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400" dirty="0">
                <a:solidFill>
                  <a:schemeClr val="bg1"/>
                </a:solidFill>
              </a:rPr>
              <a:t>Round 2</a:t>
            </a:r>
          </a:p>
        </p:txBody>
      </p:sp>
      <p:sp>
        <p:nvSpPr>
          <p:cNvPr id="7" name="Arrow: Chevron 6">
            <a:extLst>
              <a:ext uri="{FF2B5EF4-FFF2-40B4-BE49-F238E27FC236}">
                <a16:creationId xmlns:a16="http://schemas.microsoft.com/office/drawing/2014/main" id="{BB99DF0F-2AB8-019A-2597-11CFAC4173B0}"/>
              </a:ext>
            </a:extLst>
          </p:cNvPr>
          <p:cNvSpPr/>
          <p:nvPr/>
        </p:nvSpPr>
        <p:spPr>
          <a:xfrm>
            <a:off x="8909690" y="331472"/>
            <a:ext cx="3168010" cy="1295400"/>
          </a:xfrm>
          <a:prstGeom prst="chevron">
            <a:avLst/>
          </a:prstGeom>
          <a:solidFill>
            <a:schemeClr val="accent5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400" dirty="0">
                <a:solidFill>
                  <a:schemeClr val="bg1"/>
                </a:solidFill>
              </a:rPr>
              <a:t>Consensus meeting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B9973DE-DA64-40DD-774C-FD0C73A138BE}"/>
              </a:ext>
            </a:extLst>
          </p:cNvPr>
          <p:cNvSpPr/>
          <p:nvPr/>
        </p:nvSpPr>
        <p:spPr>
          <a:xfrm>
            <a:off x="163506" y="1754697"/>
            <a:ext cx="3350692" cy="940118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nduct literature review (PubMed/Medline and gray literature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31AD5E3-F90B-15EF-6AA5-08D612372071}"/>
              </a:ext>
            </a:extLst>
          </p:cNvPr>
          <p:cNvSpPr/>
          <p:nvPr/>
        </p:nvSpPr>
        <p:spPr>
          <a:xfrm>
            <a:off x="4002969" y="1754696"/>
            <a:ext cx="1997781" cy="21758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Administer questionnaire to panel:</a:t>
            </a:r>
          </a:p>
          <a:p>
            <a:endParaRPr lang="it-IT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it-IT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- Collate </a:t>
            </a:r>
            <a:r>
              <a:rPr lang="it-IT" kern="100" dirty="0" err="1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results</a:t>
            </a:r>
            <a:r>
              <a:rPr lang="it-IT" kern="100" dirty="0"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kern="100" dirty="0">
                <a:ea typeface="Aptos" panose="020B0004020202020204" pitchFamily="34" charset="0"/>
                <a:cs typeface="Times New Roman" panose="02020603050405020304" pitchFamily="18" charset="0"/>
              </a:rPr>
              <a:t>- </a:t>
            </a:r>
            <a:r>
              <a:rPr lang="it-IT" kern="100" dirty="0" err="1"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it-IT" kern="100" dirty="0" err="1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nalyze</a:t>
            </a:r>
            <a:r>
              <a:rPr lang="it-IT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it-IT" kern="100" dirty="0" err="1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results</a:t>
            </a:r>
            <a:endParaRPr lang="it-IT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B5861F4-6AA6-D00E-58D3-29AB4B477838}"/>
              </a:ext>
            </a:extLst>
          </p:cNvPr>
          <p:cNvSpPr/>
          <p:nvPr/>
        </p:nvSpPr>
        <p:spPr>
          <a:xfrm>
            <a:off x="6451423" y="1750603"/>
            <a:ext cx="1997781" cy="3739255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ify statements based on Round 1 results</a:t>
            </a:r>
          </a:p>
          <a:p>
            <a:endParaRPr lang="en-US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US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dminister revised questionnaire to panel:</a:t>
            </a:r>
            <a:endParaRPr lang="it-IT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171450" indent="-171450">
              <a:buFontTx/>
              <a:buChar char="-"/>
            </a:pPr>
            <a:r>
              <a:rPr lang="it-IT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llate </a:t>
            </a:r>
            <a:r>
              <a:rPr lang="it-IT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sults</a:t>
            </a:r>
            <a:endParaRPr lang="it-IT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171450" indent="-171450">
              <a:buFontTx/>
              <a:buChar char="-"/>
            </a:pPr>
            <a:r>
              <a:rPr lang="it-IT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lyze</a:t>
            </a:r>
            <a:r>
              <a:rPr lang="it-IT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it-IT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sults</a:t>
            </a:r>
            <a:endParaRPr lang="it-IT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1A9C1DA-DE16-9557-EF3F-4E4D2F26B013}"/>
              </a:ext>
            </a:extLst>
          </p:cNvPr>
          <p:cNvSpPr/>
          <p:nvPr/>
        </p:nvSpPr>
        <p:spPr>
          <a:xfrm>
            <a:off x="163506" y="2842644"/>
            <a:ext cx="3350692" cy="940117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eering committee interviews to identify key topics and unmet needs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CE15021-D8F2-563D-9D88-B5B19FB8BB4C}"/>
              </a:ext>
            </a:extLst>
          </p:cNvPr>
          <p:cNvSpPr/>
          <p:nvPr/>
        </p:nvSpPr>
        <p:spPr>
          <a:xfrm>
            <a:off x="123667" y="3930590"/>
            <a:ext cx="3350692" cy="262261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dirty="0" err="1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Develop</a:t>
            </a:r>
            <a:r>
              <a:rPr lang="it-IT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questionnaire</a:t>
            </a:r>
            <a:r>
              <a:rPr lang="it-IT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:</a:t>
            </a:r>
          </a:p>
          <a:p>
            <a:endParaRPr lang="it-IT" kern="100" dirty="0"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285750" indent="-285750">
              <a:buFontTx/>
              <a:buChar char="-"/>
            </a:pPr>
            <a:r>
              <a:rPr lang="en-US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Create statements based on literature and interviews</a:t>
            </a:r>
          </a:p>
          <a:p>
            <a:pPr marL="285750" indent="-285750">
              <a:buFontTx/>
              <a:buChar char="-"/>
            </a:pPr>
            <a:r>
              <a:rPr lang="en-US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Disseminate questionnaire to steering committee for feedback</a:t>
            </a:r>
          </a:p>
          <a:p>
            <a:pPr marL="285750" indent="-285750">
              <a:buFontTx/>
              <a:buChar char="-"/>
            </a:pPr>
            <a:r>
              <a:rPr lang="en-US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Refine questionnaire based on feedback</a:t>
            </a:r>
            <a:endParaRPr lang="en-US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C67DBDA-892E-5DC7-2BFA-C39A4A8AA9D1}"/>
              </a:ext>
            </a:extLst>
          </p:cNvPr>
          <p:cNvSpPr/>
          <p:nvPr/>
        </p:nvSpPr>
        <p:spPr>
          <a:xfrm>
            <a:off x="8909690" y="1750603"/>
            <a:ext cx="2476739" cy="4326347"/>
          </a:xfrm>
          <a:prstGeom prst="rect">
            <a:avLst/>
          </a:prstGeom>
          <a:solidFill>
            <a:schemeClr val="accent5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ify and generate final set of statements</a:t>
            </a:r>
          </a:p>
          <a:p>
            <a:endParaRPr lang="en-US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eering committee discussion and voting</a:t>
            </a:r>
          </a:p>
          <a:p>
            <a:endParaRPr lang="en-US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it-IT" sz="1800" b="1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nalization</a:t>
            </a:r>
            <a:r>
              <a:rPr lang="it-IT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f Consensus </a:t>
            </a:r>
            <a:r>
              <a:rPr lang="it-IT" sz="1800" b="1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atements</a:t>
            </a:r>
            <a:r>
              <a:rPr lang="en-US" sz="1800" b="1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</a:t>
            </a:r>
          </a:p>
          <a:p>
            <a:r>
              <a:rPr lang="en-US" b="1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mpile and document final recommendation</a:t>
            </a:r>
            <a:endParaRPr lang="en-US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14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05</Words>
  <Application>Microsoft Macintosh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iemonti Lorenzo</dc:creator>
  <cp:lastModifiedBy>Piemonti Lorenzo</cp:lastModifiedBy>
  <cp:revision>1</cp:revision>
  <dcterms:created xsi:type="dcterms:W3CDTF">2024-09-18T19:08:40Z</dcterms:created>
  <dcterms:modified xsi:type="dcterms:W3CDTF">2024-09-22T20:29:14Z</dcterms:modified>
</cp:coreProperties>
</file>